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n yi" initials="cy" lastIdx="3" clrIdx="0">
    <p:extLst>
      <p:ext uri="{19B8F6BF-5375-455C-9EA6-DF929625EA0E}">
        <p15:presenceInfo xmlns:p15="http://schemas.microsoft.com/office/powerpoint/2012/main" userId="65035d90f260fe9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236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5468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536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586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7520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918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19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0945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593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47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162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3801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56776-F53C-4E7B-9D66-E34CD315A44D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5AB738-C335-40CC-91DF-57840E3EF835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7294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7D6FCF04-E60B-4F5A-9630-CE71BB3E7293}"/>
              </a:ext>
            </a:extLst>
          </p:cNvPr>
          <p:cNvSpPr/>
          <p:nvPr/>
        </p:nvSpPr>
        <p:spPr>
          <a:xfrm>
            <a:off x="548192" y="1632260"/>
            <a:ext cx="606900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ETR7_gRNA1    TGTGGTCTCAATTGTGATGAAGAGGGTGTCTTTGTTTTAGAGCTAGAAATAGCAAG</a:t>
            </a:r>
          </a:p>
          <a:p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ETR7_gRNA2    TGTGGTCTCAATTGCTCTGATGTTCCATTCAAAGTTTTAGAGCTAGAAATAGCAAG</a:t>
            </a:r>
          </a:p>
          <a:p>
            <a:pPr algn="just"/>
            <a:endParaRPr lang="zh-CN" altLang="zh-CN" sz="1000" kern="100" dirty="0">
              <a:latin typeface="Courier New" panose="02070309020205020404" pitchFamily="49" charset="0"/>
              <a:ea typeface="宋体" panose="02010600030101010101" pitchFamily="2" charset="-122"/>
              <a:cs typeface="Courier New" panose="02070309020205020404" pitchFamily="49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EA3D2196-6F68-46E7-BA61-6C40F3D24F64}"/>
              </a:ext>
            </a:extLst>
          </p:cNvPr>
          <p:cNvSpPr/>
          <p:nvPr/>
        </p:nvSpPr>
        <p:spPr>
          <a:xfrm>
            <a:off x="1151755" y="2472187"/>
            <a:ext cx="18473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altLang="zh-CN" b="1" kern="100" dirty="0">
              <a:latin typeface="Courier New" panose="02070309020205020404" pitchFamily="49" charset="0"/>
              <a:ea typeface="宋体" panose="02010600030101010101" pitchFamily="2" charset="-122"/>
              <a:cs typeface="Courier New" panose="02070309020205020404" pitchFamily="49" charset="0"/>
            </a:endParaRPr>
          </a:p>
          <a:p>
            <a:pPr algn="just"/>
            <a:endParaRPr lang="en-US" altLang="zh-CN" b="1" kern="100" dirty="0">
              <a:latin typeface="Courier New" panose="02070309020205020404" pitchFamily="49" charset="0"/>
              <a:ea typeface="宋体" panose="02010600030101010101" pitchFamily="2" charset="-122"/>
              <a:cs typeface="Courier New" panose="02070309020205020404" pitchFamily="49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06E41FAC-3CA4-4929-A14A-F5E80EE8662B}"/>
              </a:ext>
            </a:extLst>
          </p:cNvPr>
          <p:cNvSpPr/>
          <p:nvPr/>
        </p:nvSpPr>
        <p:spPr>
          <a:xfrm>
            <a:off x="683298" y="2983874"/>
            <a:ext cx="3185487" cy="5539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   WT MATDSEFSNCNCDEEGVFWNIHTILDCQKV……</a:t>
            </a:r>
          </a:p>
          <a:p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KO-L1 MATDSEFSNCNCDEEVLEYTYHS*</a:t>
            </a:r>
          </a:p>
          <a:p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KO-L2 MATDSEFSNCNCDEEEYTYHS*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113F0942-8E7B-443C-830D-C66C2A9290FF}"/>
              </a:ext>
            </a:extLst>
          </p:cNvPr>
          <p:cNvSpPr/>
          <p:nvPr/>
        </p:nvSpPr>
        <p:spPr>
          <a:xfrm>
            <a:off x="210103" y="2085370"/>
            <a:ext cx="3225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B</a:t>
            </a: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41E18B76-03B1-4D27-B4CD-4AD689CC22BE}"/>
              </a:ext>
            </a:extLst>
          </p:cNvPr>
          <p:cNvSpPr/>
          <p:nvPr/>
        </p:nvSpPr>
        <p:spPr>
          <a:xfrm>
            <a:off x="389207" y="244514"/>
            <a:ext cx="6227987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altLang="zh-CN" sz="1200" b="1" u="sng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Fig. S1</a:t>
            </a:r>
            <a:r>
              <a:rPr lang="en-US" altLang="zh-CN" sz="1200" b="1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: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Details of ETR7 KO lines and OE lines,</a:t>
            </a:r>
            <a:r>
              <a:rPr lang="en-US" altLang="zh-CN" sz="1200" b="1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 </a:t>
            </a:r>
          </a:p>
          <a:p>
            <a:pPr marL="342900" indent="-342900" algn="just">
              <a:buAutoNum type="alphaUcParenR"/>
            </a:pP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Guide RNAs for CRISPR constructs; </a:t>
            </a:r>
            <a:r>
              <a:rPr lang="en-US" altLang="zh-CN" sz="1200" b="1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B)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deletions in</a:t>
            </a:r>
          </a:p>
          <a:p>
            <a:pPr algn="just"/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ETR7 gene of the two ETR7-KO lines; </a:t>
            </a:r>
            <a:r>
              <a:rPr lang="en-US" altLang="zh-CN" sz="1200" b="1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C)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ETR7 peptide </a:t>
            </a:r>
          </a:p>
          <a:p>
            <a:pPr algn="just"/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sequences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in the two ETR7-KO lines;</a:t>
            </a:r>
            <a:r>
              <a:rPr lang="en-US" altLang="zh-CN" sz="1200" b="1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 D)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relative expression</a:t>
            </a:r>
          </a:p>
          <a:p>
            <a:pPr algn="just"/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of the ETR7 gene in the two ETR7-OE lines (relative to WT, </a:t>
            </a:r>
          </a:p>
          <a:p>
            <a:pPr algn="just"/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set at 1),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“*”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stands for significant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difference </a:t>
            </a:r>
            <a:r>
              <a:rPr lang="en-US" altLang="zh-CN" sz="1200" kern="100" dirty="0" smtClean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at 5 % by t-test</a:t>
            </a:r>
            <a:endParaRPr lang="en-US" altLang="zh-CN" sz="1200" kern="100" dirty="0">
              <a:latin typeface="Courier New" panose="02070309020205020404" pitchFamily="49" charset="0"/>
              <a:ea typeface="宋体" panose="02010600030101010101" pitchFamily="2" charset="-122"/>
              <a:cs typeface="Courier New" panose="02070309020205020404" pitchFamily="49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39431C72-21BE-41CE-83B9-4EBF5091F11F}"/>
              </a:ext>
            </a:extLst>
          </p:cNvPr>
          <p:cNvSpPr/>
          <p:nvPr/>
        </p:nvSpPr>
        <p:spPr>
          <a:xfrm>
            <a:off x="225668" y="1566161"/>
            <a:ext cx="3225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8D364A87-BF53-4DCC-AFEB-669288C64306}"/>
              </a:ext>
            </a:extLst>
          </p:cNvPr>
          <p:cNvSpPr/>
          <p:nvPr/>
        </p:nvSpPr>
        <p:spPr>
          <a:xfrm>
            <a:off x="208642" y="3151823"/>
            <a:ext cx="3225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C</a:t>
            </a: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3C29F8AB-A047-4B79-935F-1839CA84A176}"/>
              </a:ext>
            </a:extLst>
          </p:cNvPr>
          <p:cNvSpPr/>
          <p:nvPr/>
        </p:nvSpPr>
        <p:spPr>
          <a:xfrm>
            <a:off x="215208" y="3832352"/>
            <a:ext cx="3225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latin typeface="Courier New" panose="02070309020205020404" pitchFamily="49" charset="0"/>
                <a:ea typeface="宋体" panose="02010600030101010101" pitchFamily="2" charset="-122"/>
                <a:cs typeface="Courier New" panose="02070309020205020404" pitchFamily="49" charset="0"/>
              </a:rPr>
              <a:t>D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64D95494-B42A-4BE7-B6A1-1AB39AF140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4700" y="3503213"/>
            <a:ext cx="2678175" cy="3372065"/>
          </a:xfrm>
          <a:prstGeom prst="rect">
            <a:avLst/>
          </a:prstGeom>
        </p:spPr>
      </p:pic>
      <p:grpSp>
        <p:nvGrpSpPr>
          <p:cNvPr id="10" name="Groupe 9"/>
          <p:cNvGrpSpPr/>
          <p:nvPr/>
        </p:nvGrpSpPr>
        <p:grpSpPr>
          <a:xfrm>
            <a:off x="171193" y="2261672"/>
            <a:ext cx="6622294" cy="702365"/>
            <a:chOff x="171193" y="2087492"/>
            <a:chExt cx="6622294" cy="702365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DAB4555-0018-4305-BFB4-717AF91BA5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193" y="2087492"/>
              <a:ext cx="6622294" cy="702365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243478" y="2237475"/>
              <a:ext cx="481222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altLang="zh-CN" sz="800" b="1" dirty="0" smtClean="0">
                  <a:latin typeface="Century Gothic" panose="020B0502020202020204" pitchFamily="34" charset="0"/>
                  <a:cs typeface="Courier New" panose="02070309020205020404" pitchFamily="49" charset="0"/>
                </a:rPr>
                <a:t>WT</a:t>
              </a:r>
            </a:p>
            <a:p>
              <a:r>
                <a:rPr lang="en-US" altLang="zh-CN" sz="800" b="1" dirty="0" smtClean="0">
                  <a:latin typeface="Century Gothic" panose="020B0502020202020204" pitchFamily="34" charset="0"/>
                  <a:cs typeface="Courier New" panose="02070309020205020404" pitchFamily="49" charset="0"/>
                </a:rPr>
                <a:t>KO-L1</a:t>
              </a:r>
            </a:p>
            <a:p>
              <a:r>
                <a:rPr lang="en-US" sz="800" b="1" dirty="0" smtClean="0">
                  <a:latin typeface="Century Gothic" panose="020B0502020202020204" pitchFamily="34" charset="0"/>
                  <a:cs typeface="Courier New" panose="02070309020205020404" pitchFamily="49" charset="0"/>
                </a:rPr>
                <a:t>KO-L2</a:t>
              </a:r>
              <a:endParaRPr lang="fr-FR" sz="800" b="1" dirty="0">
                <a:latin typeface="Century Gothic" panose="020B0502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2188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</TotalTime>
  <Words>97</Words>
  <Application>Microsoft Office PowerPoint</Application>
  <PresentationFormat>Format A4 (210 x 297 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8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Century Gothic</vt:lpstr>
      <vt:lpstr>Courier New</vt:lpstr>
      <vt:lpstr>等线</vt:lpstr>
      <vt:lpstr>等线 Light</vt:lpstr>
      <vt:lpstr>Office 主题​​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yi</dc:creator>
  <cp:lastModifiedBy>cchervin</cp:lastModifiedBy>
  <cp:revision>31</cp:revision>
  <dcterms:created xsi:type="dcterms:W3CDTF">2019-05-13T12:24:27Z</dcterms:created>
  <dcterms:modified xsi:type="dcterms:W3CDTF">2019-09-29T19:19:21Z</dcterms:modified>
</cp:coreProperties>
</file>